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2" d="100"/>
          <a:sy n="92" d="100"/>
        </p:scale>
        <p:origin x="25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raig Heck" userId="e1fb993239fb696d" providerId="LiveId" clId="{6C8446C2-7BE4-450F-8AF7-F3338DB7E070}"/>
    <pc:docChg chg="undo custSel addSld modSld">
      <pc:chgData name="Craig Heck" userId="e1fb993239fb696d" providerId="LiveId" clId="{6C8446C2-7BE4-450F-8AF7-F3338DB7E070}" dt="2024-04-03T12:09:24.199" v="1355" actId="255"/>
      <pc:docMkLst>
        <pc:docMk/>
      </pc:docMkLst>
      <pc:sldChg chg="addSp delSp modSp new mod">
        <pc:chgData name="Craig Heck" userId="e1fb993239fb696d" providerId="LiveId" clId="{6C8446C2-7BE4-450F-8AF7-F3338DB7E070}" dt="2024-04-03T12:09:24.199" v="1355" actId="255"/>
        <pc:sldMkLst>
          <pc:docMk/>
          <pc:sldMk cId="2135039470" sldId="256"/>
        </pc:sldMkLst>
        <pc:spChg chg="del">
          <ac:chgData name="Craig Heck" userId="e1fb993239fb696d" providerId="LiveId" clId="{6C8446C2-7BE4-450F-8AF7-F3338DB7E070}" dt="2024-04-01T16:22:55.442" v="1" actId="478"/>
          <ac:spMkLst>
            <pc:docMk/>
            <pc:sldMk cId="2135039470" sldId="256"/>
            <ac:spMk id="2" creationId="{7357E9C8-2847-C979-25DF-F455DAA3BE09}"/>
          </ac:spMkLst>
        </pc:spChg>
        <pc:spChg chg="add mod">
          <ac:chgData name="Craig Heck" userId="e1fb993239fb696d" providerId="LiveId" clId="{6C8446C2-7BE4-450F-8AF7-F3338DB7E070}" dt="2024-04-02T22:21:20.098" v="1337" actId="20577"/>
          <ac:spMkLst>
            <pc:docMk/>
            <pc:sldMk cId="2135039470" sldId="256"/>
            <ac:spMk id="2" creationId="{C4DBB1DC-2F45-631E-CA76-DC7B2D4FFC1E}"/>
          </ac:spMkLst>
        </pc:spChg>
        <pc:spChg chg="del">
          <ac:chgData name="Craig Heck" userId="e1fb993239fb696d" providerId="LiveId" clId="{6C8446C2-7BE4-450F-8AF7-F3338DB7E070}" dt="2024-04-01T16:22:56.384" v="2" actId="478"/>
          <ac:spMkLst>
            <pc:docMk/>
            <pc:sldMk cId="2135039470" sldId="256"/>
            <ac:spMk id="3" creationId="{7EF7B897-BDA7-1E96-2A2A-61ECBD261930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4" creationId="{49C4CE4E-EA47-3711-6DC1-38E1FE01F494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5" creationId="{6544EB57-4392-3376-AB5E-268FEA842626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6" creationId="{433F60C6-5224-882D-E783-D051A7F413D0}"/>
          </ac:spMkLst>
        </pc:spChg>
        <pc:spChg chg="add mod">
          <ac:chgData name="Craig Heck" userId="e1fb993239fb696d" providerId="LiveId" clId="{6C8446C2-7BE4-450F-8AF7-F3338DB7E070}" dt="2024-04-01T17:12:42.224" v="1285" actId="1036"/>
          <ac:spMkLst>
            <pc:docMk/>
            <pc:sldMk cId="2135039470" sldId="256"/>
            <ac:spMk id="7" creationId="{943527A6-8C5E-33B1-F449-763F93B16510}"/>
          </ac:spMkLst>
        </pc:spChg>
        <pc:spChg chg="add mod">
          <ac:chgData name="Craig Heck" userId="e1fb993239fb696d" providerId="LiveId" clId="{6C8446C2-7BE4-450F-8AF7-F3338DB7E070}" dt="2024-04-01T17:12:42.224" v="1285" actId="1036"/>
          <ac:spMkLst>
            <pc:docMk/>
            <pc:sldMk cId="2135039470" sldId="256"/>
            <ac:spMk id="8" creationId="{FAA834A3-C5BF-DA14-42F7-48AACE19A4AE}"/>
          </ac:spMkLst>
        </pc:spChg>
        <pc:spChg chg="add mod">
          <ac:chgData name="Craig Heck" userId="e1fb993239fb696d" providerId="LiveId" clId="{6C8446C2-7BE4-450F-8AF7-F3338DB7E070}" dt="2024-04-01T17:12:42.224" v="1285" actId="1036"/>
          <ac:spMkLst>
            <pc:docMk/>
            <pc:sldMk cId="2135039470" sldId="256"/>
            <ac:spMk id="9" creationId="{3A9AF02E-4D91-808F-02FD-418BFB526F4F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10" creationId="{8972B678-77D6-4C0B-F845-C6280FD208A1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11" creationId="{AD511A8D-F585-6825-BA22-156FA80DB9E3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12" creationId="{2722CC83-66D8-9B9F-C153-FD5BD8869435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13" creationId="{86DE24AD-E44B-C824-C088-77B8DF058474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14" creationId="{1283E9E4-D433-B8ED-87AD-2EAAD895A168}"/>
          </ac:spMkLst>
        </pc:spChg>
        <pc:spChg chg="add mod">
          <ac:chgData name="Craig Heck" userId="e1fb993239fb696d" providerId="LiveId" clId="{6C8446C2-7BE4-450F-8AF7-F3338DB7E070}" dt="2024-04-02T22:21:41.325" v="1341" actId="13822"/>
          <ac:spMkLst>
            <pc:docMk/>
            <pc:sldMk cId="2135039470" sldId="256"/>
            <ac:spMk id="15" creationId="{CE6A30E5-54F9-26C0-B0CC-FDEB95D20EBE}"/>
          </ac:spMkLst>
        </pc:spChg>
        <pc:spChg chg="add del mod">
          <ac:chgData name="Craig Heck" userId="e1fb993239fb696d" providerId="LiveId" clId="{6C8446C2-7BE4-450F-8AF7-F3338DB7E070}" dt="2024-04-01T16:44:44.186" v="655" actId="478"/>
          <ac:spMkLst>
            <pc:docMk/>
            <pc:sldMk cId="2135039470" sldId="256"/>
            <ac:spMk id="15" creationId="{EF701E83-99C6-DCD1-D74A-60BAC57149B5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16" creationId="{F7F39A41-1119-9B52-7925-FB311FE3A730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17" creationId="{253BE8BA-C2ED-21D4-96FC-D44386894C9D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18" creationId="{A4F0ADB5-B2F3-546D-AB76-6688F3325DD1}"/>
          </ac:spMkLst>
        </pc:spChg>
        <pc:spChg chg="add del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26" creationId="{774C3B25-3437-4946-B971-7DBBBE6A8016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27" creationId="{09C5DC9C-8F59-1A28-7E1F-E84D0AE7996E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28" creationId="{55F2A05D-4D8B-A9B3-B389-FD2F418587DC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29" creationId="{F552DA92-0C1C-F16B-23E4-59D53E38E3AF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32" creationId="{FA936B13-2AB7-962B-8C72-BEF126B8696C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33" creationId="{58676D30-D1E7-8AD1-E8C0-378C009603F9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34" creationId="{7051F4D2-EFB0-3D7C-E1B1-5078969C481A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38" creationId="{1F74E56C-2C15-B359-8144-09D02F7B9112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39" creationId="{943EF85F-10FC-8AF5-BE74-2997EA72904C}"/>
          </ac:spMkLst>
        </pc:spChg>
        <pc:spChg chg="add del mod">
          <ac:chgData name="Craig Heck" userId="e1fb993239fb696d" providerId="LiveId" clId="{6C8446C2-7BE4-450F-8AF7-F3338DB7E070}" dt="2024-04-01T16:44:50.425" v="658" actId="478"/>
          <ac:spMkLst>
            <pc:docMk/>
            <pc:sldMk cId="2135039470" sldId="256"/>
            <ac:spMk id="40" creationId="{2A443125-E9F9-E665-5175-10C643C5E9C2}"/>
          </ac:spMkLst>
        </pc:spChg>
        <pc:spChg chg="add del mod">
          <ac:chgData name="Craig Heck" userId="e1fb993239fb696d" providerId="LiveId" clId="{6C8446C2-7BE4-450F-8AF7-F3338DB7E070}" dt="2024-04-01T16:50:37.730" v="827" actId="478"/>
          <ac:spMkLst>
            <pc:docMk/>
            <pc:sldMk cId="2135039470" sldId="256"/>
            <ac:spMk id="42" creationId="{4ED14797-7AE7-29B3-4112-3C9088DB7C51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46" creationId="{E6DC50EA-1529-A7FE-DB87-F44B53242779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47" creationId="{2873DE46-4FDD-F227-4E9D-9A00A3EBF906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48" creationId="{4671189E-4321-01F9-F777-0B087C4229D8}"/>
          </ac:spMkLst>
        </pc:spChg>
        <pc:spChg chg="add mod">
          <ac:chgData name="Craig Heck" userId="e1fb993239fb696d" providerId="LiveId" clId="{6C8446C2-7BE4-450F-8AF7-F3338DB7E070}" dt="2024-04-01T17:11:02.540" v="1146" actId="1036"/>
          <ac:spMkLst>
            <pc:docMk/>
            <pc:sldMk cId="2135039470" sldId="256"/>
            <ac:spMk id="50" creationId="{1E3B92B1-E696-D25C-1247-89EBCFC960FE}"/>
          </ac:spMkLst>
        </pc:spChg>
        <pc:spChg chg="add mod">
          <ac:chgData name="Craig Heck" userId="e1fb993239fb696d" providerId="LiveId" clId="{6C8446C2-7BE4-450F-8AF7-F3338DB7E070}" dt="2024-04-01T16:54:04.417" v="1082" actId="6549"/>
          <ac:spMkLst>
            <pc:docMk/>
            <pc:sldMk cId="2135039470" sldId="256"/>
            <ac:spMk id="69" creationId="{9F2F64A2-B6F4-CB8B-5C92-517B04D20AA7}"/>
          </ac:spMkLst>
        </pc:spChg>
        <pc:spChg chg="add mod">
          <ac:chgData name="Craig Heck" userId="e1fb993239fb696d" providerId="LiveId" clId="{6C8446C2-7BE4-450F-8AF7-F3338DB7E070}" dt="2024-04-02T22:22:06.707" v="1348" actId="14100"/>
          <ac:spMkLst>
            <pc:docMk/>
            <pc:sldMk cId="2135039470" sldId="256"/>
            <ac:spMk id="70" creationId="{9A81933F-525D-86EF-FB22-A0A6877FDF45}"/>
          </ac:spMkLst>
        </pc:spChg>
        <pc:spChg chg="add mod">
          <ac:chgData name="Craig Heck" userId="e1fb993239fb696d" providerId="LiveId" clId="{6C8446C2-7BE4-450F-8AF7-F3338DB7E070}" dt="2024-04-03T12:09:24.199" v="1355" actId="255"/>
          <ac:spMkLst>
            <pc:docMk/>
            <pc:sldMk cId="2135039470" sldId="256"/>
            <ac:spMk id="95" creationId="{8346D291-F1FD-C0D4-4799-F97332D53CFF}"/>
          </ac:spMkLst>
        </pc:spChg>
        <pc:cxnChg chg="add mod">
          <ac:chgData name="Craig Heck" userId="e1fb993239fb696d" providerId="LiveId" clId="{6C8446C2-7BE4-450F-8AF7-F3338DB7E070}" dt="2024-04-02T22:21:37.231" v="1339" actId="1076"/>
          <ac:cxnSpMkLst>
            <pc:docMk/>
            <pc:sldMk cId="2135039470" sldId="256"/>
            <ac:cxnSpMk id="19" creationId="{0ECAA60C-2CB4-6E73-810E-BE37F46B4D24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20" creationId="{50B32385-1E80-9C95-B3DF-10558365C7D1}"/>
          </ac:cxnSpMkLst>
        </pc:cxnChg>
        <pc:cxnChg chg="add mod">
          <ac:chgData name="Craig Heck" userId="e1fb993239fb696d" providerId="LiveId" clId="{6C8446C2-7BE4-450F-8AF7-F3338DB7E070}" dt="2024-04-02T22:21:48.308" v="1345" actId="14100"/>
          <ac:cxnSpMkLst>
            <pc:docMk/>
            <pc:sldMk cId="2135039470" sldId="256"/>
            <ac:cxnSpMk id="21" creationId="{0D9B858D-E9F3-4588-DEA0-B60724456F1C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23" creationId="{85C3CCDC-5E1A-E47C-C186-81EDF6982745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25" creationId="{5F295821-AF20-DA6B-5AD3-97C63D6ACF11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31" creationId="{B4540C3F-3B1A-3873-850E-7DA369C384DB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35" creationId="{0F6D0698-6CCF-79A9-B059-04F8504FE172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36" creationId="{CBDCA66D-04CA-1510-72D5-7569A1DE2AFB}"/>
          </ac:cxnSpMkLst>
        </pc:cxnChg>
        <pc:cxnChg chg="add del mod">
          <ac:chgData name="Craig Heck" userId="e1fb993239fb696d" providerId="LiveId" clId="{6C8446C2-7BE4-450F-8AF7-F3338DB7E070}" dt="2024-04-01T16:44:45.048" v="656" actId="478"/>
          <ac:cxnSpMkLst>
            <pc:docMk/>
            <pc:sldMk cId="2135039470" sldId="256"/>
            <ac:cxnSpMk id="37" creationId="{674A114E-C765-5172-85B3-F9969FAD729F}"/>
          </ac:cxnSpMkLst>
        </pc:cxnChg>
        <pc:cxnChg chg="add mod">
          <ac:chgData name="Craig Heck" userId="e1fb993239fb696d" providerId="LiveId" clId="{6C8446C2-7BE4-450F-8AF7-F3338DB7E070}" dt="2024-04-02T22:21:13.598" v="1332" actId="14100"/>
          <ac:cxnSpMkLst>
            <pc:docMk/>
            <pc:sldMk cId="2135039470" sldId="256"/>
            <ac:cxnSpMk id="41" creationId="{7A3CEC80-B47D-FEDA-BDB3-08E5DB2F8CCB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43" creationId="{926147FB-3E56-50E8-61B1-2125ACC40F46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44" creationId="{45BB229E-3459-7F7E-3280-C4A15C18910D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45" creationId="{61DACDFC-7BA6-6751-4917-81C8E3BE1D74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49" creationId="{CB33A670-12C5-136A-E28D-6D0BDF7A81CE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72" creationId="{5AEE98F7-4B34-CBB8-0E81-1925D38A7410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73" creationId="{153CDEB7-4BCD-F8FD-F16B-5740A6DEED28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75" creationId="{B39053B7-F943-3C89-CA56-00F298E2C2CF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77" creationId="{6B09ABD5-FD73-F94B-5269-AED15D8DE3C5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81" creationId="{998F8829-6417-5269-30C0-22B6695B238C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84" creationId="{1F8AD83A-09EB-5749-D2D3-7CD93FD8A78C}"/>
          </ac:cxnSpMkLst>
        </pc:cxnChg>
        <pc:cxnChg chg="add mod">
          <ac:chgData name="Craig Heck" userId="e1fb993239fb696d" providerId="LiveId" clId="{6C8446C2-7BE4-450F-8AF7-F3338DB7E070}" dt="2024-04-02T22:22:15.532" v="1350" actId="14100"/>
          <ac:cxnSpMkLst>
            <pc:docMk/>
            <pc:sldMk cId="2135039470" sldId="256"/>
            <ac:cxnSpMk id="86" creationId="{F706822D-FBF6-A3FA-AAA6-9F6A99AA232A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88" creationId="{364D20BA-AB86-BDAC-6318-0464D6FDD651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89" creationId="{ADADB670-9239-6E4B-41EC-416AD2D50B9A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92" creationId="{BBD77B5E-618B-A097-59A4-004E4489E80B}"/>
          </ac:cxnSpMkLst>
        </pc:cxnChg>
        <pc:cxnChg chg="add mod">
          <ac:chgData name="Craig Heck" userId="e1fb993239fb696d" providerId="LiveId" clId="{6C8446C2-7BE4-450F-8AF7-F3338DB7E070}" dt="2024-04-01T17:11:02.540" v="1146" actId="1036"/>
          <ac:cxnSpMkLst>
            <pc:docMk/>
            <pc:sldMk cId="2135039470" sldId="256"/>
            <ac:cxnSpMk id="94" creationId="{DB802A9B-94D4-4A02-D189-71560301A4E8}"/>
          </ac:cxnSpMkLst>
        </pc:cxnChg>
      </pc:sldChg>
    </pc:docChg>
  </pc:docChgLst>
  <pc:docChgLst>
    <pc:chgData name="Craig Heck" userId="e1fb993239fb696d" providerId="LiveId" clId="{DE432E6C-7A07-4CAC-99F4-3307A4902431}"/>
    <pc:docChg chg="modSld">
      <pc:chgData name="Craig Heck" userId="e1fb993239fb696d" providerId="LiveId" clId="{DE432E6C-7A07-4CAC-99F4-3307A4902431}" dt="2024-08-19T11:50:39.912" v="23" actId="1035"/>
      <pc:docMkLst>
        <pc:docMk/>
      </pc:docMkLst>
      <pc:sldChg chg="modSp mod">
        <pc:chgData name="Craig Heck" userId="e1fb993239fb696d" providerId="LiveId" clId="{DE432E6C-7A07-4CAC-99F4-3307A4902431}" dt="2024-08-19T11:50:39.912" v="23" actId="1035"/>
        <pc:sldMkLst>
          <pc:docMk/>
          <pc:sldMk cId="2135039470" sldId="256"/>
        </pc:sldMkLst>
        <pc:spChg chg="mod">
          <ac:chgData name="Craig Heck" userId="e1fb993239fb696d" providerId="LiveId" clId="{DE432E6C-7A07-4CAC-99F4-3307A4902431}" dt="2024-08-19T11:50:39.912" v="23" actId="1035"/>
          <ac:spMkLst>
            <pc:docMk/>
            <pc:sldMk cId="2135039470" sldId="256"/>
            <ac:spMk id="7" creationId="{943527A6-8C5E-33B1-F449-763F93B16510}"/>
          </ac:spMkLst>
        </pc:spChg>
        <pc:spChg chg="mod">
          <ac:chgData name="Craig Heck" userId="e1fb993239fb696d" providerId="LiveId" clId="{DE432E6C-7A07-4CAC-99F4-3307A4902431}" dt="2024-08-19T11:50:39.912" v="23" actId="1035"/>
          <ac:spMkLst>
            <pc:docMk/>
            <pc:sldMk cId="2135039470" sldId="256"/>
            <ac:spMk id="8" creationId="{FAA834A3-C5BF-DA14-42F7-48AACE19A4AE}"/>
          </ac:spMkLst>
        </pc:spChg>
        <pc:spChg chg="mod">
          <ac:chgData name="Craig Heck" userId="e1fb993239fb696d" providerId="LiveId" clId="{DE432E6C-7A07-4CAC-99F4-3307A4902431}" dt="2024-08-19T11:50:39.912" v="23" actId="1035"/>
          <ac:spMkLst>
            <pc:docMk/>
            <pc:sldMk cId="2135039470" sldId="256"/>
            <ac:spMk id="9" creationId="{3A9AF02E-4D91-808F-02FD-418BFB526F4F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5C5AD9-5018-42FE-A49B-0DA5D431EE9E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9A89EC-AE0E-4B4C-8E77-7E14A1A5A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006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9A89EC-AE0E-4B4C-8E77-7E14A1A5AC8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9958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384F67-4225-409A-E9BF-F3523ABD7F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D71B37C-F7B2-C86A-47CF-A7057E14AC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5D0F3C-DC38-C726-D574-8C1D01A098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A531-FE51-4F23-8760-F23135DB2DF9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D096CA-7099-D69B-22C2-0A39CCD214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58117E-D7F4-BC4D-F281-4F194CC706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46502-EBFA-4910-B03B-99A7D80FF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208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76FD6F-23DB-4E82-E807-62D6191CD4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377F1B4-F700-D0ED-CDD9-4892C8A52D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9318BF-06E0-6055-C731-0294A5692E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A531-FE51-4F23-8760-F23135DB2DF9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6BAB33-C614-4A6A-89B9-00FB11A6C8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ECB752-6A2B-254F-5AC8-81EEA3A0C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46502-EBFA-4910-B03B-99A7D80FF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0028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D442435-B064-CB70-CBC0-C6B707CD33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DA4FADD-7897-2871-1D99-2A6C4C1DAA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E41D1D-FD70-6C12-4F1E-7CEA077BC0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A531-FE51-4F23-8760-F23135DB2DF9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F79430-0314-E7E7-22F1-7223ABCB55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817C91-0DED-44AE-2676-B0A7056A48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46502-EBFA-4910-B03B-99A7D80FF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910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6D0330-D2E9-EA42-D4A2-972D6E1BED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6B39AE-D466-01FC-96FF-F404EFE183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0531E2-31F2-9E81-F73C-86F81A768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A531-FE51-4F23-8760-F23135DB2DF9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6AC1FD-89FB-6C34-81C1-A411E531B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1C50ED-0AB4-B6CC-9EB6-E22B1CE3B1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46502-EBFA-4910-B03B-99A7D80FF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3772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B13D7E-AA83-A7B6-6A5E-F9EED42B78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495ED9-6282-AE5C-4376-76D988BEE5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739AAD-48A3-A213-DF52-D532CB399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A531-FE51-4F23-8760-F23135DB2DF9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A5AB83-BB73-CF4C-7847-6549E1BD8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DE273C-AD96-A285-3104-5D51452972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46502-EBFA-4910-B03B-99A7D80FF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827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101C8E-84A5-5049-FB94-825EA994A5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A8E26C-1F79-7192-178C-1357E7CFF8B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67A9467-2250-2E3E-BB84-B01A424357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24B34D-41F2-A679-F8A3-29D0FFEBE5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A531-FE51-4F23-8760-F23135DB2DF9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57B038-1C1B-B8B3-4B44-7482924474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8BF239-8521-656D-EE96-D9E4F7DF35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46502-EBFA-4910-B03B-99A7D80FF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0522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AE77B4-268B-5247-1569-BF2494566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E9E094-AAAE-B658-BBF2-39E5C8B941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F4B49C-DE14-BE82-591A-333F8BC584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91D3935-3B34-C071-B9BA-47507DF9DD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ABD5C3D-C83F-C5B0-E8B0-7C1C044EB54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3C9DE40-C467-4C31-71C7-F1B1EDAB8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A531-FE51-4F23-8760-F23135DB2DF9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22D75A-5245-9CE9-90FA-94EF73281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66DFC08-1851-3006-1A6B-EF2CB499B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46502-EBFA-4910-B03B-99A7D80FF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6951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A4C625-D95B-92B4-EB67-E19078C97A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CF3209-0319-D7CB-FDD1-1B5BBB535D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A531-FE51-4F23-8760-F23135DB2DF9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64CECD3-164C-3412-4540-A6CB768E0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0B402C2-36DB-23E5-B190-55CDCA43F3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46502-EBFA-4910-B03B-99A7D80FF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1926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12E2526-0285-7C9C-5975-ECBF50239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A531-FE51-4F23-8760-F23135DB2DF9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70BA16D-8A77-F4A1-F2D1-6F73540DBE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7920B7D-A845-87E0-46AB-D055A8ABA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46502-EBFA-4910-B03B-99A7D80FF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424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99576A-60C7-9238-8A53-23287E5616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7ABCCB-DB28-57DD-D49D-1DA4A00B08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923BB2-E80E-D7E7-4BA7-222139F38D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1C57F8-FE52-20C1-1949-740CE14CD0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A531-FE51-4F23-8760-F23135DB2DF9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0EEA9C-82EA-DC33-BECA-3594F344F5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21B4EE-3722-9AAC-E7D9-6D8C1D7817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46502-EBFA-4910-B03B-99A7D80FF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708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D68504-410F-45D3-0221-FB8141802C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207B766-D92A-F5D4-2368-A08B5C2D2E8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142BBD-CFBC-0EFE-0620-F8C14E4466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0AC79D-A12A-ACC2-D399-2BD9AAC11C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A531-FE51-4F23-8760-F23135DB2DF9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6AF6C0-6A14-4D28-F918-E2D9D4AB2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9FD8CE-C2D9-A536-61E3-11325BC495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546502-EBFA-4910-B03B-99A7D80FF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2882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4C8F4AD-CD63-53D7-5C2D-5EFC78AEFA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1283C5-253A-5A3E-5258-BCE7ABA8FE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8CB686-FB28-C7AE-059C-8B76865733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B4A531-FE51-4F23-8760-F23135DB2DF9}" type="datetimeFigureOut">
              <a:rPr lang="en-US" smtClean="0"/>
              <a:t>8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D9A889-0E5C-D0FC-CF8B-6185EFBCBFC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1D2F77-0151-25F9-6996-5DBFDF7344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546502-EBFA-4910-B03B-99A7D80FF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418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49C4CE4E-EA47-3711-6DC1-38E1FE01F494}"/>
              </a:ext>
            </a:extLst>
          </p:cNvPr>
          <p:cNvSpPr/>
          <p:nvPr/>
        </p:nvSpPr>
        <p:spPr>
          <a:xfrm>
            <a:off x="310393" y="881063"/>
            <a:ext cx="2302778" cy="476118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1777 AGYW</a:t>
            </a:r>
          </a:p>
        </p:txBody>
      </p: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6544EB57-4392-3376-AB5E-268FEA842626}"/>
              </a:ext>
            </a:extLst>
          </p:cNvPr>
          <p:cNvSpPr/>
          <p:nvPr/>
        </p:nvSpPr>
        <p:spPr>
          <a:xfrm>
            <a:off x="4517779" y="881061"/>
            <a:ext cx="2302778" cy="475488"/>
          </a:xfrm>
          <a:prstGeom prst="roundRect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1672 AGYW</a:t>
            </a:r>
          </a:p>
        </p:txBody>
      </p: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433F60C6-5224-882D-E783-D051A7F413D0}"/>
              </a:ext>
            </a:extLst>
          </p:cNvPr>
          <p:cNvSpPr/>
          <p:nvPr/>
        </p:nvSpPr>
        <p:spPr>
          <a:xfrm>
            <a:off x="8341510" y="881060"/>
            <a:ext cx="2302778" cy="475488"/>
          </a:xfrm>
          <a:prstGeom prst="roundRect">
            <a:avLst/>
          </a:prstGeom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1915 AGYW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943527A6-8C5E-33B1-F449-763F93B16510}"/>
              </a:ext>
            </a:extLst>
          </p:cNvPr>
          <p:cNvSpPr/>
          <p:nvPr/>
        </p:nvSpPr>
        <p:spPr>
          <a:xfrm>
            <a:off x="797150" y="321690"/>
            <a:ext cx="1179683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2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Kenya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AA834A3-C5BF-DA14-42F7-48AACE19A4AE}"/>
              </a:ext>
            </a:extLst>
          </p:cNvPr>
          <p:cNvSpPr/>
          <p:nvPr/>
        </p:nvSpPr>
        <p:spPr>
          <a:xfrm>
            <a:off x="4950755" y="326068"/>
            <a:ext cx="1409745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2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Malawi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A9AF02E-4D91-808F-02FD-418BFB526F4F}"/>
              </a:ext>
            </a:extLst>
          </p:cNvPr>
          <p:cNvSpPr/>
          <p:nvPr/>
        </p:nvSpPr>
        <p:spPr>
          <a:xfrm>
            <a:off x="8797110" y="321689"/>
            <a:ext cx="1408975" cy="58477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32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Zambia</a:t>
            </a:r>
          </a:p>
        </p:txBody>
      </p:sp>
      <p:sp>
        <p:nvSpPr>
          <p:cNvPr id="10" name="Rectangle: Rounded Corners 9">
            <a:extLst>
              <a:ext uri="{FF2B5EF4-FFF2-40B4-BE49-F238E27FC236}">
                <a16:creationId xmlns:a16="http://schemas.microsoft.com/office/drawing/2014/main" id="{8972B678-77D6-4C0B-F845-C6280FD208A1}"/>
              </a:ext>
            </a:extLst>
          </p:cNvPr>
          <p:cNvSpPr/>
          <p:nvPr/>
        </p:nvSpPr>
        <p:spPr>
          <a:xfrm>
            <a:off x="310393" y="2153219"/>
            <a:ext cx="2302778" cy="476118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860 AGYW</a:t>
            </a:r>
          </a:p>
        </p:txBody>
      </p:sp>
      <p:sp>
        <p:nvSpPr>
          <p:cNvPr id="11" name="Rectangle: Rounded Corners 10">
            <a:extLst>
              <a:ext uri="{FF2B5EF4-FFF2-40B4-BE49-F238E27FC236}">
                <a16:creationId xmlns:a16="http://schemas.microsoft.com/office/drawing/2014/main" id="{AD511A8D-F585-6825-BA22-156FA80DB9E3}"/>
              </a:ext>
            </a:extLst>
          </p:cNvPr>
          <p:cNvSpPr/>
          <p:nvPr/>
        </p:nvSpPr>
        <p:spPr>
          <a:xfrm>
            <a:off x="310393" y="3425375"/>
            <a:ext cx="2302778" cy="476118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782 AGYW</a:t>
            </a:r>
          </a:p>
        </p:txBody>
      </p:sp>
      <p:sp>
        <p:nvSpPr>
          <p:cNvPr id="12" name="Rectangle: Rounded Corners 11">
            <a:extLst>
              <a:ext uri="{FF2B5EF4-FFF2-40B4-BE49-F238E27FC236}">
                <a16:creationId xmlns:a16="http://schemas.microsoft.com/office/drawing/2014/main" id="{2722CC83-66D8-9B9F-C153-FD5BD8869435}"/>
              </a:ext>
            </a:extLst>
          </p:cNvPr>
          <p:cNvSpPr/>
          <p:nvPr/>
        </p:nvSpPr>
        <p:spPr>
          <a:xfrm>
            <a:off x="310393" y="4697531"/>
            <a:ext cx="2302778" cy="476118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768 AGYW</a:t>
            </a:r>
          </a:p>
        </p:txBody>
      </p:sp>
      <p:sp>
        <p:nvSpPr>
          <p:cNvPr id="13" name="Rectangle: Rounded Corners 12">
            <a:extLst>
              <a:ext uri="{FF2B5EF4-FFF2-40B4-BE49-F238E27FC236}">
                <a16:creationId xmlns:a16="http://schemas.microsoft.com/office/drawing/2014/main" id="{86DE24AD-E44B-C824-C088-77B8DF058474}"/>
              </a:ext>
            </a:extLst>
          </p:cNvPr>
          <p:cNvSpPr/>
          <p:nvPr/>
        </p:nvSpPr>
        <p:spPr>
          <a:xfrm>
            <a:off x="4517779" y="2152586"/>
            <a:ext cx="2302778" cy="476118"/>
          </a:xfrm>
          <a:prstGeom prst="roundRect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1455 AGYW</a:t>
            </a:r>
          </a:p>
        </p:txBody>
      </p:sp>
      <p:sp>
        <p:nvSpPr>
          <p:cNvPr id="14" name="Rectangle: Rounded Corners 13">
            <a:extLst>
              <a:ext uri="{FF2B5EF4-FFF2-40B4-BE49-F238E27FC236}">
                <a16:creationId xmlns:a16="http://schemas.microsoft.com/office/drawing/2014/main" id="{1283E9E4-D433-B8ED-87AD-2EAAD895A168}"/>
              </a:ext>
            </a:extLst>
          </p:cNvPr>
          <p:cNvSpPr/>
          <p:nvPr/>
        </p:nvSpPr>
        <p:spPr>
          <a:xfrm>
            <a:off x="4517779" y="3424741"/>
            <a:ext cx="2302778" cy="476118"/>
          </a:xfrm>
          <a:prstGeom prst="roundRect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1381 AGYW</a:t>
            </a:r>
          </a:p>
        </p:txBody>
      </p:sp>
      <p:sp>
        <p:nvSpPr>
          <p:cNvPr id="16" name="Rectangle: Rounded Corners 15">
            <a:extLst>
              <a:ext uri="{FF2B5EF4-FFF2-40B4-BE49-F238E27FC236}">
                <a16:creationId xmlns:a16="http://schemas.microsoft.com/office/drawing/2014/main" id="{F7F39A41-1119-9B52-7925-FB311FE3A730}"/>
              </a:ext>
            </a:extLst>
          </p:cNvPr>
          <p:cNvSpPr/>
          <p:nvPr/>
        </p:nvSpPr>
        <p:spPr>
          <a:xfrm>
            <a:off x="8341510" y="2152198"/>
            <a:ext cx="2302778" cy="476118"/>
          </a:xfrm>
          <a:prstGeom prst="roundRect">
            <a:avLst/>
          </a:prstGeom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454 AGYW</a:t>
            </a:r>
          </a:p>
        </p:txBody>
      </p:sp>
      <p:sp>
        <p:nvSpPr>
          <p:cNvPr id="17" name="Rectangle: Rounded Corners 16">
            <a:extLst>
              <a:ext uri="{FF2B5EF4-FFF2-40B4-BE49-F238E27FC236}">
                <a16:creationId xmlns:a16="http://schemas.microsoft.com/office/drawing/2014/main" id="{253BE8BA-C2ED-21D4-96FC-D44386894C9D}"/>
              </a:ext>
            </a:extLst>
          </p:cNvPr>
          <p:cNvSpPr/>
          <p:nvPr/>
        </p:nvSpPr>
        <p:spPr>
          <a:xfrm>
            <a:off x="8341510" y="3423966"/>
            <a:ext cx="2302778" cy="476118"/>
          </a:xfrm>
          <a:prstGeom prst="roundRect">
            <a:avLst/>
          </a:prstGeom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372 AGYW</a:t>
            </a:r>
          </a:p>
        </p:txBody>
      </p:sp>
      <p:sp>
        <p:nvSpPr>
          <p:cNvPr id="18" name="Rectangle: Rounded Corners 17">
            <a:extLst>
              <a:ext uri="{FF2B5EF4-FFF2-40B4-BE49-F238E27FC236}">
                <a16:creationId xmlns:a16="http://schemas.microsoft.com/office/drawing/2014/main" id="{A4F0ADB5-B2F3-546D-AB76-6688F3325DD1}"/>
              </a:ext>
            </a:extLst>
          </p:cNvPr>
          <p:cNvSpPr/>
          <p:nvPr/>
        </p:nvSpPr>
        <p:spPr>
          <a:xfrm>
            <a:off x="8341510" y="4695734"/>
            <a:ext cx="2302778" cy="476118"/>
          </a:xfrm>
          <a:prstGeom prst="roundRect">
            <a:avLst/>
          </a:prstGeom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371 AGYW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50B32385-1E80-9C95-B3DF-10558365C7D1}"/>
              </a:ext>
            </a:extLst>
          </p:cNvPr>
          <p:cNvCxnSpPr>
            <a:cxnSpLocks/>
            <a:stCxn id="4" idx="2"/>
            <a:endCxn id="10" idx="0"/>
          </p:cNvCxnSpPr>
          <p:nvPr/>
        </p:nvCxnSpPr>
        <p:spPr>
          <a:xfrm>
            <a:off x="1461782" y="1357181"/>
            <a:ext cx="0" cy="7960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85C3CCDC-5E1A-E47C-C186-81EDF6982745}"/>
              </a:ext>
            </a:extLst>
          </p:cNvPr>
          <p:cNvCxnSpPr>
            <a:stCxn id="10" idx="2"/>
            <a:endCxn id="11" idx="0"/>
          </p:cNvCxnSpPr>
          <p:nvPr/>
        </p:nvCxnSpPr>
        <p:spPr>
          <a:xfrm>
            <a:off x="1461782" y="2629337"/>
            <a:ext cx="0" cy="7960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5F295821-AF20-DA6B-5AD3-97C63D6ACF11}"/>
              </a:ext>
            </a:extLst>
          </p:cNvPr>
          <p:cNvCxnSpPr>
            <a:stCxn id="11" idx="2"/>
            <a:endCxn id="12" idx="0"/>
          </p:cNvCxnSpPr>
          <p:nvPr/>
        </p:nvCxnSpPr>
        <p:spPr>
          <a:xfrm>
            <a:off x="1461782" y="3901493"/>
            <a:ext cx="0" cy="7960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Rectangle 25">
            <a:extLst>
              <a:ext uri="{FF2B5EF4-FFF2-40B4-BE49-F238E27FC236}">
                <a16:creationId xmlns:a16="http://schemas.microsoft.com/office/drawing/2014/main" id="{774C3B25-3437-4946-B971-7DBBBE6A8016}"/>
              </a:ext>
            </a:extLst>
          </p:cNvPr>
          <p:cNvSpPr/>
          <p:nvPr/>
        </p:nvSpPr>
        <p:spPr>
          <a:xfrm>
            <a:off x="2301463" y="1517140"/>
            <a:ext cx="1500527" cy="47611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917 not sexually active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09C5DC9C-8F59-1A28-7E1F-E84D0AE7996E}"/>
              </a:ext>
            </a:extLst>
          </p:cNvPr>
          <p:cNvSpPr/>
          <p:nvPr/>
        </p:nvSpPr>
        <p:spPr>
          <a:xfrm>
            <a:off x="2301463" y="2789296"/>
            <a:ext cx="1500527" cy="47611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78 not HIV negative†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55F2A05D-4D8B-A9B3-B389-FD2F418587DC}"/>
              </a:ext>
            </a:extLst>
          </p:cNvPr>
          <p:cNvSpPr/>
          <p:nvPr/>
        </p:nvSpPr>
        <p:spPr>
          <a:xfrm>
            <a:off x="2301463" y="4079138"/>
            <a:ext cx="1500527" cy="47611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14 missing outcome data</a:t>
            </a:r>
          </a:p>
        </p:txBody>
      </p:sp>
      <p:sp>
        <p:nvSpPr>
          <p:cNvPr id="29" name="Rectangle: Rounded Corners 28">
            <a:extLst>
              <a:ext uri="{FF2B5EF4-FFF2-40B4-BE49-F238E27FC236}">
                <a16:creationId xmlns:a16="http://schemas.microsoft.com/office/drawing/2014/main" id="{F552DA92-0C1C-F16B-23E4-59D53E38E3AF}"/>
              </a:ext>
            </a:extLst>
          </p:cNvPr>
          <p:cNvSpPr/>
          <p:nvPr/>
        </p:nvSpPr>
        <p:spPr>
          <a:xfrm>
            <a:off x="310393" y="5969687"/>
            <a:ext cx="2302778" cy="476118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746 AGYW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B4540C3F-3B1A-3873-850E-7DA369C384DB}"/>
              </a:ext>
            </a:extLst>
          </p:cNvPr>
          <p:cNvCxnSpPr>
            <a:stCxn id="12" idx="2"/>
            <a:endCxn id="29" idx="0"/>
          </p:cNvCxnSpPr>
          <p:nvPr/>
        </p:nvCxnSpPr>
        <p:spPr>
          <a:xfrm>
            <a:off x="1461782" y="5173649"/>
            <a:ext cx="0" cy="7960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Rectangle 31">
            <a:extLst>
              <a:ext uri="{FF2B5EF4-FFF2-40B4-BE49-F238E27FC236}">
                <a16:creationId xmlns:a16="http://schemas.microsoft.com/office/drawing/2014/main" id="{FA936B13-2AB7-962B-8C72-BEF126B8696C}"/>
              </a:ext>
            </a:extLst>
          </p:cNvPr>
          <p:cNvSpPr/>
          <p:nvPr/>
        </p:nvSpPr>
        <p:spPr>
          <a:xfrm>
            <a:off x="2301463" y="5230888"/>
            <a:ext cx="1500527" cy="701335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22 responded “Don’t know” for outcome</a:t>
            </a:r>
          </a:p>
        </p:txBody>
      </p:sp>
      <p:sp>
        <p:nvSpPr>
          <p:cNvPr id="33" name="Rectangle: Rounded Corners 32">
            <a:extLst>
              <a:ext uri="{FF2B5EF4-FFF2-40B4-BE49-F238E27FC236}">
                <a16:creationId xmlns:a16="http://schemas.microsoft.com/office/drawing/2014/main" id="{58676D30-D1E7-8AD1-E8C0-378C009603F9}"/>
              </a:ext>
            </a:extLst>
          </p:cNvPr>
          <p:cNvSpPr/>
          <p:nvPr/>
        </p:nvSpPr>
        <p:spPr>
          <a:xfrm>
            <a:off x="4517779" y="5967502"/>
            <a:ext cx="2302778" cy="476118"/>
          </a:xfrm>
          <a:prstGeom prst="roundRect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1348 AGYW</a:t>
            </a:r>
          </a:p>
        </p:txBody>
      </p:sp>
      <p:sp>
        <p:nvSpPr>
          <p:cNvPr id="34" name="Rectangle: Rounded Corners 33">
            <a:extLst>
              <a:ext uri="{FF2B5EF4-FFF2-40B4-BE49-F238E27FC236}">
                <a16:creationId xmlns:a16="http://schemas.microsoft.com/office/drawing/2014/main" id="{7051F4D2-EFB0-3D7C-E1B1-5078969C481A}"/>
              </a:ext>
            </a:extLst>
          </p:cNvPr>
          <p:cNvSpPr/>
          <p:nvPr/>
        </p:nvSpPr>
        <p:spPr>
          <a:xfrm>
            <a:off x="8341510" y="5967502"/>
            <a:ext cx="2302778" cy="476118"/>
          </a:xfrm>
          <a:prstGeom prst="roundRect">
            <a:avLst/>
          </a:prstGeom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349 AGYW</a:t>
            </a:r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0F6D0698-6CCF-79A9-B059-04F8504FE172}"/>
              </a:ext>
            </a:extLst>
          </p:cNvPr>
          <p:cNvCxnSpPr>
            <a:cxnSpLocks/>
            <a:stCxn id="5" idx="2"/>
            <a:endCxn id="13" idx="0"/>
          </p:cNvCxnSpPr>
          <p:nvPr/>
        </p:nvCxnSpPr>
        <p:spPr>
          <a:xfrm>
            <a:off x="5669168" y="1356549"/>
            <a:ext cx="0" cy="79603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CBDCA66D-04CA-1510-72D5-7569A1DE2AFB}"/>
              </a:ext>
            </a:extLst>
          </p:cNvPr>
          <p:cNvCxnSpPr>
            <a:cxnSpLocks/>
            <a:stCxn id="13" idx="2"/>
            <a:endCxn id="14" idx="0"/>
          </p:cNvCxnSpPr>
          <p:nvPr/>
        </p:nvCxnSpPr>
        <p:spPr>
          <a:xfrm>
            <a:off x="5669168" y="2628704"/>
            <a:ext cx="0" cy="79603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Rectangle 37">
            <a:extLst>
              <a:ext uri="{FF2B5EF4-FFF2-40B4-BE49-F238E27FC236}">
                <a16:creationId xmlns:a16="http://schemas.microsoft.com/office/drawing/2014/main" id="{1F74E56C-2C15-B359-8144-09D02F7B9112}"/>
              </a:ext>
            </a:extLst>
          </p:cNvPr>
          <p:cNvSpPr/>
          <p:nvPr/>
        </p:nvSpPr>
        <p:spPr>
          <a:xfrm>
            <a:off x="6435683" y="1561483"/>
            <a:ext cx="1500527" cy="476119"/>
          </a:xfrm>
          <a:prstGeom prst="rect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217 not sexually active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943EF85F-10FC-8AF5-BE74-2997EA72904C}"/>
              </a:ext>
            </a:extLst>
          </p:cNvPr>
          <p:cNvSpPr/>
          <p:nvPr/>
        </p:nvSpPr>
        <p:spPr>
          <a:xfrm>
            <a:off x="6435682" y="2833639"/>
            <a:ext cx="1500527" cy="476119"/>
          </a:xfrm>
          <a:prstGeom prst="rect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74 not HIV negative†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7A3CEC80-B47D-FEDA-BDB3-08E5DB2F8CCB}"/>
              </a:ext>
            </a:extLst>
          </p:cNvPr>
          <p:cNvCxnSpPr>
            <a:cxnSpLocks/>
            <a:stCxn id="14" idx="2"/>
            <a:endCxn id="2" idx="0"/>
          </p:cNvCxnSpPr>
          <p:nvPr/>
        </p:nvCxnSpPr>
        <p:spPr>
          <a:xfrm>
            <a:off x="5669168" y="3900859"/>
            <a:ext cx="114" cy="79487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926147FB-3E56-50E8-61B1-2125ACC40F46}"/>
              </a:ext>
            </a:extLst>
          </p:cNvPr>
          <p:cNvCxnSpPr>
            <a:cxnSpLocks/>
            <a:stCxn id="6" idx="2"/>
            <a:endCxn id="16" idx="0"/>
          </p:cNvCxnSpPr>
          <p:nvPr/>
        </p:nvCxnSpPr>
        <p:spPr>
          <a:xfrm>
            <a:off x="9492899" y="1356548"/>
            <a:ext cx="0" cy="7956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45BB229E-3459-7F7E-3280-C4A15C18910D}"/>
              </a:ext>
            </a:extLst>
          </p:cNvPr>
          <p:cNvCxnSpPr>
            <a:cxnSpLocks/>
            <a:stCxn id="16" idx="2"/>
            <a:endCxn id="17" idx="0"/>
          </p:cNvCxnSpPr>
          <p:nvPr/>
        </p:nvCxnSpPr>
        <p:spPr>
          <a:xfrm>
            <a:off x="9492899" y="2628316"/>
            <a:ext cx="0" cy="7956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61DACDFC-7BA6-6751-4917-81C8E3BE1D74}"/>
              </a:ext>
            </a:extLst>
          </p:cNvPr>
          <p:cNvCxnSpPr>
            <a:cxnSpLocks/>
            <a:stCxn id="17" idx="2"/>
            <a:endCxn id="18" idx="0"/>
          </p:cNvCxnSpPr>
          <p:nvPr/>
        </p:nvCxnSpPr>
        <p:spPr>
          <a:xfrm>
            <a:off x="9492899" y="3900084"/>
            <a:ext cx="0" cy="7956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Rectangle 45">
            <a:extLst>
              <a:ext uri="{FF2B5EF4-FFF2-40B4-BE49-F238E27FC236}">
                <a16:creationId xmlns:a16="http://schemas.microsoft.com/office/drawing/2014/main" id="{E6DC50EA-1529-A7FE-DB87-F44B53242779}"/>
              </a:ext>
            </a:extLst>
          </p:cNvPr>
          <p:cNvSpPr/>
          <p:nvPr/>
        </p:nvSpPr>
        <p:spPr>
          <a:xfrm>
            <a:off x="10341280" y="1504433"/>
            <a:ext cx="1500527" cy="476119"/>
          </a:xfrm>
          <a:prstGeom prst="rect">
            <a:avLst/>
          </a:prstGeom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1461 not sexually active‡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2873DE46-4FDD-F227-4E9D-9A00A3EBF906}"/>
              </a:ext>
            </a:extLst>
          </p:cNvPr>
          <p:cNvSpPr/>
          <p:nvPr/>
        </p:nvSpPr>
        <p:spPr>
          <a:xfrm>
            <a:off x="10341279" y="2776589"/>
            <a:ext cx="1500527" cy="476119"/>
          </a:xfrm>
          <a:prstGeom prst="rect">
            <a:avLst/>
          </a:prstGeom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82 not HIV negative†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4671189E-4321-01F9-F777-0B087C4229D8}"/>
              </a:ext>
            </a:extLst>
          </p:cNvPr>
          <p:cNvSpPr/>
          <p:nvPr/>
        </p:nvSpPr>
        <p:spPr>
          <a:xfrm>
            <a:off x="10341279" y="4066431"/>
            <a:ext cx="1500527" cy="476119"/>
          </a:xfrm>
          <a:prstGeom prst="rect">
            <a:avLst/>
          </a:prstGeom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1 missing outcome data</a:t>
            </a:r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CB33A670-12C5-136A-E28D-6D0BDF7A81CE}"/>
              </a:ext>
            </a:extLst>
          </p:cNvPr>
          <p:cNvCxnSpPr>
            <a:cxnSpLocks/>
            <a:stCxn id="18" idx="2"/>
          </p:cNvCxnSpPr>
          <p:nvPr/>
        </p:nvCxnSpPr>
        <p:spPr>
          <a:xfrm>
            <a:off x="9492899" y="5171852"/>
            <a:ext cx="8700" cy="7851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Rectangle 49">
            <a:extLst>
              <a:ext uri="{FF2B5EF4-FFF2-40B4-BE49-F238E27FC236}">
                <a16:creationId xmlns:a16="http://schemas.microsoft.com/office/drawing/2014/main" id="{1E3B92B1-E696-D25C-1247-89EBCFC960FE}"/>
              </a:ext>
            </a:extLst>
          </p:cNvPr>
          <p:cNvSpPr/>
          <p:nvPr/>
        </p:nvSpPr>
        <p:spPr>
          <a:xfrm>
            <a:off x="10341279" y="5212912"/>
            <a:ext cx="1500527" cy="704088"/>
          </a:xfrm>
          <a:prstGeom prst="rect">
            <a:avLst/>
          </a:prstGeom>
        </p:spPr>
        <p:style>
          <a:lnRef idx="2">
            <a:schemeClr val="accent2">
              <a:shade val="15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22 responded “Don’t know” for outcome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9F2F64A2-B6F4-CB8B-5C92-517B04D20AA7}"/>
              </a:ext>
            </a:extLst>
          </p:cNvPr>
          <p:cNvSpPr txBox="1"/>
          <p:nvPr/>
        </p:nvSpPr>
        <p:spPr>
          <a:xfrm>
            <a:off x="0" y="6434248"/>
            <a:ext cx="1218862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0" i="0" dirty="0">
                <a:solidFill>
                  <a:srgbClr val="1C1D1E"/>
                </a:solidFill>
                <a:effectLst/>
              </a:rPr>
              <a:t>† Includes self-reported HIV positive, Don’t know, No response, or Missing data</a:t>
            </a:r>
          </a:p>
          <a:p>
            <a:r>
              <a:rPr lang="en-US" sz="1200" dirty="0">
                <a:solidFill>
                  <a:srgbClr val="1C1D1E"/>
                </a:solidFill>
              </a:rPr>
              <a:t>‡ Comparatively smaller than the other samples because a more-restrictive skip logic was erroneously applied to the sexual behavior questions of this sample  </a:t>
            </a: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9A81933F-525D-86EF-FB22-A0A6877FDF45}"/>
              </a:ext>
            </a:extLst>
          </p:cNvPr>
          <p:cNvSpPr/>
          <p:nvPr/>
        </p:nvSpPr>
        <p:spPr>
          <a:xfrm>
            <a:off x="6517661" y="5212912"/>
            <a:ext cx="1500527" cy="701335"/>
          </a:xfrm>
          <a:prstGeom prst="rect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33 responded “Don’t know” for outcome</a:t>
            </a:r>
          </a:p>
        </p:txBody>
      </p: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5AEE98F7-4B34-CBB8-0E81-1925D38A7410}"/>
              </a:ext>
            </a:extLst>
          </p:cNvPr>
          <p:cNvCxnSpPr>
            <a:endCxn id="26" idx="1"/>
          </p:cNvCxnSpPr>
          <p:nvPr/>
        </p:nvCxnSpPr>
        <p:spPr>
          <a:xfrm flipV="1">
            <a:off x="1461782" y="1755200"/>
            <a:ext cx="8396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153CDEB7-4BCD-F8FD-F16B-5740A6DEED28}"/>
              </a:ext>
            </a:extLst>
          </p:cNvPr>
          <p:cNvCxnSpPr>
            <a:cxnSpLocks/>
            <a:endCxn id="27" idx="1"/>
          </p:cNvCxnSpPr>
          <p:nvPr/>
        </p:nvCxnSpPr>
        <p:spPr>
          <a:xfrm>
            <a:off x="1461781" y="3026722"/>
            <a:ext cx="839682" cy="63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B39053B7-F943-3C89-CA56-00F298E2C2CF}"/>
              </a:ext>
            </a:extLst>
          </p:cNvPr>
          <p:cNvCxnSpPr>
            <a:cxnSpLocks/>
            <a:endCxn id="28" idx="1"/>
          </p:cNvCxnSpPr>
          <p:nvPr/>
        </p:nvCxnSpPr>
        <p:spPr>
          <a:xfrm>
            <a:off x="1461781" y="4316952"/>
            <a:ext cx="839682" cy="24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6B09ABD5-FD73-F94B-5269-AED15D8DE3C5}"/>
              </a:ext>
            </a:extLst>
          </p:cNvPr>
          <p:cNvCxnSpPr>
            <a:cxnSpLocks/>
            <a:endCxn id="32" idx="1"/>
          </p:cNvCxnSpPr>
          <p:nvPr/>
        </p:nvCxnSpPr>
        <p:spPr>
          <a:xfrm>
            <a:off x="1461781" y="5564956"/>
            <a:ext cx="83968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998F8829-6417-5269-30C0-22B6695B238C}"/>
              </a:ext>
            </a:extLst>
          </p:cNvPr>
          <p:cNvCxnSpPr>
            <a:cxnSpLocks/>
            <a:endCxn id="38" idx="1"/>
          </p:cNvCxnSpPr>
          <p:nvPr/>
        </p:nvCxnSpPr>
        <p:spPr>
          <a:xfrm>
            <a:off x="5669168" y="1794457"/>
            <a:ext cx="76651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id="{1F8AD83A-09EB-5749-D2D3-7CD93FD8A78C}"/>
              </a:ext>
            </a:extLst>
          </p:cNvPr>
          <p:cNvCxnSpPr>
            <a:endCxn id="39" idx="1"/>
          </p:cNvCxnSpPr>
          <p:nvPr/>
        </p:nvCxnSpPr>
        <p:spPr>
          <a:xfrm>
            <a:off x="5669168" y="3071698"/>
            <a:ext cx="766514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F706822D-FBF6-A3FA-AAA6-9F6A99AA232A}"/>
              </a:ext>
            </a:extLst>
          </p:cNvPr>
          <p:cNvCxnSpPr>
            <a:cxnSpLocks/>
            <a:endCxn id="70" idx="1"/>
          </p:cNvCxnSpPr>
          <p:nvPr/>
        </p:nvCxnSpPr>
        <p:spPr>
          <a:xfrm>
            <a:off x="5669168" y="5563580"/>
            <a:ext cx="84849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364D20BA-AB86-BDAC-6318-0464D6FDD651}"/>
              </a:ext>
            </a:extLst>
          </p:cNvPr>
          <p:cNvCxnSpPr>
            <a:endCxn id="46" idx="1"/>
          </p:cNvCxnSpPr>
          <p:nvPr/>
        </p:nvCxnSpPr>
        <p:spPr>
          <a:xfrm>
            <a:off x="9501599" y="1742492"/>
            <a:ext cx="839681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ADADB670-9239-6E4B-41EC-416AD2D50B9A}"/>
              </a:ext>
            </a:extLst>
          </p:cNvPr>
          <p:cNvCxnSpPr>
            <a:cxnSpLocks/>
            <a:endCxn id="47" idx="1"/>
          </p:cNvCxnSpPr>
          <p:nvPr/>
        </p:nvCxnSpPr>
        <p:spPr>
          <a:xfrm flipV="1">
            <a:off x="9501598" y="3014649"/>
            <a:ext cx="8396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BBD77B5E-618B-A097-59A4-004E4489E80B}"/>
              </a:ext>
            </a:extLst>
          </p:cNvPr>
          <p:cNvCxnSpPr>
            <a:endCxn id="48" idx="1"/>
          </p:cNvCxnSpPr>
          <p:nvPr/>
        </p:nvCxnSpPr>
        <p:spPr>
          <a:xfrm flipV="1">
            <a:off x="9492899" y="4304491"/>
            <a:ext cx="84838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DB802A9B-94D4-4A02-D189-71560301A4E8}"/>
              </a:ext>
            </a:extLst>
          </p:cNvPr>
          <p:cNvCxnSpPr>
            <a:endCxn id="50" idx="1"/>
          </p:cNvCxnSpPr>
          <p:nvPr/>
        </p:nvCxnSpPr>
        <p:spPr>
          <a:xfrm>
            <a:off x="9492899" y="5564956"/>
            <a:ext cx="84838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8346D291-F1FD-C0D4-4799-F97332D53CFF}"/>
              </a:ext>
            </a:extLst>
          </p:cNvPr>
          <p:cNvSpPr txBox="1"/>
          <p:nvPr/>
        </p:nvSpPr>
        <p:spPr>
          <a:xfrm>
            <a:off x="-66501" y="-58222"/>
            <a:ext cx="12564686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500" b="1" dirty="0"/>
              <a:t>Supplemental Material 2. CONSORT diagrams highlighting analytic exclusions and samples</a:t>
            </a:r>
          </a:p>
        </p:txBody>
      </p:sp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C4DBB1DC-2F45-631E-CA76-DC7B2D4FFC1E}"/>
              </a:ext>
            </a:extLst>
          </p:cNvPr>
          <p:cNvSpPr/>
          <p:nvPr/>
        </p:nvSpPr>
        <p:spPr>
          <a:xfrm>
            <a:off x="4517893" y="4695734"/>
            <a:ext cx="2302778" cy="476118"/>
          </a:xfrm>
          <a:prstGeom prst="roundRect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1381 AGYW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E6A30E5-54F9-26C0-B0CC-FDEB95D20EBE}"/>
              </a:ext>
            </a:extLst>
          </p:cNvPr>
          <p:cNvSpPr/>
          <p:nvPr/>
        </p:nvSpPr>
        <p:spPr>
          <a:xfrm>
            <a:off x="6517661" y="4064295"/>
            <a:ext cx="1500527" cy="476119"/>
          </a:xfrm>
          <a:prstGeom prst="rect">
            <a:avLst/>
          </a:prstGeom>
        </p:spPr>
        <p:style>
          <a:lnRef idx="2">
            <a:schemeClr val="accent6">
              <a:shade val="15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/>
              <a:t>0 missing outcome data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0ECAA60C-2CB4-6E73-810E-BE37F46B4D24}"/>
              </a:ext>
            </a:extLst>
          </p:cNvPr>
          <p:cNvCxnSpPr>
            <a:cxnSpLocks/>
            <a:endCxn id="15" idx="1"/>
          </p:cNvCxnSpPr>
          <p:nvPr/>
        </p:nvCxnSpPr>
        <p:spPr>
          <a:xfrm>
            <a:off x="5677979" y="4302109"/>
            <a:ext cx="839682" cy="24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0D9B858D-E9F3-4588-DEA0-B60724456F1C}"/>
              </a:ext>
            </a:extLst>
          </p:cNvPr>
          <p:cNvCxnSpPr>
            <a:cxnSpLocks/>
            <a:stCxn id="2" idx="2"/>
            <a:endCxn id="33" idx="0"/>
          </p:cNvCxnSpPr>
          <p:nvPr/>
        </p:nvCxnSpPr>
        <p:spPr>
          <a:xfrm flipH="1">
            <a:off x="5669168" y="5171852"/>
            <a:ext cx="114" cy="7956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35039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147</Words>
  <Application>Microsoft Office PowerPoint</Application>
  <PresentationFormat>Widescreen</PresentationFormat>
  <Paragraphs>3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ck, Craig J.</dc:creator>
  <cp:lastModifiedBy>Heck, Craig J.</cp:lastModifiedBy>
  <cp:revision>1</cp:revision>
  <dcterms:created xsi:type="dcterms:W3CDTF">2024-04-01T16:22:52Z</dcterms:created>
  <dcterms:modified xsi:type="dcterms:W3CDTF">2024-08-19T11:50:46Z</dcterms:modified>
</cp:coreProperties>
</file>